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86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1376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684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9174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325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862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39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934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802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86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3614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6FB39-4B21-482F-A911-956A199E64F5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C7982-C4D9-47E5-8E73-892A597ED4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640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1690872" y="0"/>
            <a:ext cx="8448388" cy="5272391"/>
            <a:chOff x="18860" y="-1569278"/>
            <a:chExt cx="12592878" cy="9482306"/>
          </a:xfrm>
        </p:grpSpPr>
        <p:grpSp>
          <p:nvGrpSpPr>
            <p:cNvPr id="6" name="组合 5"/>
            <p:cNvGrpSpPr/>
            <p:nvPr/>
          </p:nvGrpSpPr>
          <p:grpSpPr>
            <a:xfrm>
              <a:off x="18860" y="-1569278"/>
              <a:ext cx="12592878" cy="9482306"/>
              <a:chOff x="1172020" y="-1203976"/>
              <a:chExt cx="12592878" cy="9482306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29" t="-2694" r="665" b="11425"/>
              <a:stretch/>
            </p:blipFill>
            <p:spPr>
              <a:xfrm>
                <a:off x="1172020" y="-1203976"/>
                <a:ext cx="12592878" cy="9482306"/>
              </a:xfrm>
              <a:prstGeom prst="rect">
                <a:avLst/>
              </a:prstGeom>
            </p:spPr>
          </p:pic>
          <p:sp>
            <p:nvSpPr>
              <p:cNvPr id="10" name="文本框 67"/>
              <p:cNvSpPr txBox="1"/>
              <p:nvPr/>
            </p:nvSpPr>
            <p:spPr>
              <a:xfrm>
                <a:off x="2483307" y="1719359"/>
                <a:ext cx="988978" cy="498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bp</a:t>
                </a:r>
                <a:endParaRPr lang="zh-CN" alt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67"/>
              <p:cNvSpPr txBox="1"/>
              <p:nvPr/>
            </p:nvSpPr>
            <p:spPr>
              <a:xfrm>
                <a:off x="2502043" y="4642695"/>
                <a:ext cx="1175491" cy="498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</a:t>
                </a:r>
                <a:endParaRPr lang="zh-CN" alt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67"/>
              <p:cNvSpPr txBox="1"/>
              <p:nvPr/>
            </p:nvSpPr>
            <p:spPr>
              <a:xfrm>
                <a:off x="2530736" y="2993786"/>
                <a:ext cx="1103757" cy="456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5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bp</a:t>
                </a:r>
                <a:endParaRPr lang="zh-CN" alt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58"/>
              <p:cNvSpPr txBox="1"/>
              <p:nvPr/>
            </p:nvSpPr>
            <p:spPr>
              <a:xfrm>
                <a:off x="2718989" y="-723247"/>
                <a:ext cx="363627" cy="6642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zh-CN" alt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" name="组合 13"/>
              <p:cNvGrpSpPr/>
              <p:nvPr/>
            </p:nvGrpSpPr>
            <p:grpSpPr>
              <a:xfrm>
                <a:off x="5687224" y="-1085049"/>
                <a:ext cx="3413232" cy="680970"/>
                <a:chOff x="5687224" y="-1085049"/>
                <a:chExt cx="3413232" cy="680970"/>
              </a:xfrm>
            </p:grpSpPr>
            <p:sp>
              <p:nvSpPr>
                <p:cNvPr id="15" name="文本框 58"/>
                <p:cNvSpPr txBox="1"/>
                <p:nvPr/>
              </p:nvSpPr>
              <p:spPr>
                <a:xfrm>
                  <a:off x="6046562" y="-1057958"/>
                  <a:ext cx="391361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zh-CN" altLang="en-US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58"/>
                <p:cNvSpPr txBox="1"/>
                <p:nvPr/>
              </p:nvSpPr>
              <p:spPr>
                <a:xfrm>
                  <a:off x="7707076" y="-1068316"/>
                  <a:ext cx="391361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zh-CN" altLang="en-US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文本框 58"/>
                <p:cNvSpPr txBox="1"/>
                <p:nvPr/>
              </p:nvSpPr>
              <p:spPr>
                <a:xfrm>
                  <a:off x="8039668" y="-1073891"/>
                  <a:ext cx="391361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zh-CN" altLang="en-US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文本框 58"/>
                <p:cNvSpPr txBox="1"/>
                <p:nvPr/>
              </p:nvSpPr>
              <p:spPr>
                <a:xfrm>
                  <a:off x="6365099" y="-1056003"/>
                  <a:ext cx="290638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文本框 58"/>
                <p:cNvSpPr txBox="1"/>
                <p:nvPr/>
              </p:nvSpPr>
              <p:spPr>
                <a:xfrm>
                  <a:off x="6648198" y="-1068316"/>
                  <a:ext cx="479988" cy="6642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文本框 58"/>
                <p:cNvSpPr txBox="1"/>
                <p:nvPr/>
              </p:nvSpPr>
              <p:spPr>
                <a:xfrm>
                  <a:off x="7025971" y="-1068316"/>
                  <a:ext cx="290638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文本框 58"/>
                <p:cNvSpPr txBox="1"/>
                <p:nvPr/>
              </p:nvSpPr>
              <p:spPr>
                <a:xfrm>
                  <a:off x="7338459" y="-1068314"/>
                  <a:ext cx="290638" cy="369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文本框 58"/>
                <p:cNvSpPr txBox="1"/>
                <p:nvPr/>
              </p:nvSpPr>
              <p:spPr>
                <a:xfrm>
                  <a:off x="5687224" y="-1085049"/>
                  <a:ext cx="445420" cy="6642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文本框 58"/>
                <p:cNvSpPr txBox="1"/>
                <p:nvPr/>
              </p:nvSpPr>
              <p:spPr>
                <a:xfrm>
                  <a:off x="8656026" y="-1085049"/>
                  <a:ext cx="444430" cy="369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58"/>
                <p:cNvSpPr txBox="1"/>
                <p:nvPr/>
              </p:nvSpPr>
              <p:spPr>
                <a:xfrm>
                  <a:off x="8352156" y="-1056003"/>
                  <a:ext cx="290638" cy="369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7" name="直接箭头连接符 6"/>
            <p:cNvCxnSpPr/>
            <p:nvPr/>
          </p:nvCxnSpPr>
          <p:spPr>
            <a:xfrm flipV="1">
              <a:off x="4772945" y="3902222"/>
              <a:ext cx="321962" cy="1039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/>
            <p:nvPr/>
          </p:nvCxnSpPr>
          <p:spPr>
            <a:xfrm flipV="1">
              <a:off x="6411591" y="3851303"/>
              <a:ext cx="321962" cy="1039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矩形 24"/>
          <p:cNvSpPr/>
          <p:nvPr/>
        </p:nvSpPr>
        <p:spPr>
          <a:xfrm>
            <a:off x="807930" y="5297399"/>
            <a:ext cx="1082541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600" kern="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.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iginal </a:t>
            </a:r>
            <a:r>
              <a:rPr lang="en-US" altLang="zh-CN" sz="1600" kern="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l image 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Figure 2</a:t>
            </a:r>
            <a:endParaRPr lang="zh-CN" altLang="zh-CN" sz="16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te: 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forward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quence and reverse sequence of the double-ended anchoring primer were: GGCACCCGGACATCAGTT and GGGGCTAAGACAAGTCTACCAG. The red narrows 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 DNA fragment specific to </a:t>
            </a:r>
            <a:r>
              <a:rPr lang="en-US" altLang="zh-CN" sz="16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. intermedium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M, marker (2 kb ladder); 1: </a:t>
            </a:r>
            <a:r>
              <a:rPr lang="en-US" altLang="zh-CN" sz="16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. intermedium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2: SN304, 3: YN15, A: Chinese Spring, B: </a:t>
            </a:r>
            <a:r>
              <a:rPr lang="en-US" altLang="zh-CN" sz="16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inopyrum</a:t>
            </a:r>
            <a:r>
              <a:rPr lang="en-US" altLang="zh-CN" sz="16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longatum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6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: RIL-150, D: RIL-164, E: RIL-257, F: RIL-264, G: RIL-296.</a:t>
            </a:r>
            <a:endParaRPr lang="zh-CN" altLang="zh-CN" sz="16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圆角矩形 25"/>
          <p:cNvSpPr/>
          <p:nvPr/>
        </p:nvSpPr>
        <p:spPr>
          <a:xfrm>
            <a:off x="4844588" y="1885714"/>
            <a:ext cx="2480237" cy="1612940"/>
          </a:xfrm>
          <a:prstGeom prst="round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6062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11</Words>
  <Application>Microsoft Office PowerPoint</Application>
  <PresentationFormat>宽屏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x</dc:creator>
  <cp:lastModifiedBy>zx</cp:lastModifiedBy>
  <cp:revision>13</cp:revision>
  <dcterms:created xsi:type="dcterms:W3CDTF">2024-02-21T17:23:39Z</dcterms:created>
  <dcterms:modified xsi:type="dcterms:W3CDTF">2024-02-21T17:48:15Z</dcterms:modified>
</cp:coreProperties>
</file>